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BB7A08-9CA1-4C7E-886B-17C62590695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B214CD-848E-4BDE-AE16-CAE3A15693D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5E4589-4280-499E-ABD7-490B852111D0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FABA75-E3C8-4B83-9EBA-5F515A9B49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2B9923-E9A6-4A38-8495-41F6FF299C0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6DEA2-87F7-4B8E-A66F-3588EEA09E6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814304-C623-4593-A68C-31D0C32A94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241463F-89D2-4E3D-83A2-B9D656CA6E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B1BABF2-C525-4011-8C4B-AD451A24E5E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ABFF12-9231-4C33-8570-D423E6CABAD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5EC5B2-366F-496F-AB82-4CDD80B106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7A56F4-194B-41CA-A024-08C1F81CE5C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8C1B30C-0EB4-44FE-AE1B-4FD01D17BC60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ZoneTexte 3"/>
          <p:cNvSpPr/>
          <p:nvPr/>
        </p:nvSpPr>
        <p:spPr>
          <a:xfrm>
            <a:off x="187560" y="254160"/>
            <a:ext cx="8010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 u="sng">
                <a:solidFill>
                  <a:srgbClr val="000000"/>
                </a:solidFill>
                <a:uFillTx/>
                <a:latin typeface="Calibri"/>
                <a:ea typeface="Arial"/>
              </a:rPr>
              <a:t>S2 Table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777960" y="988920"/>
          <a:ext cx="4862520" cy="2800440"/>
        </p:xfrm>
        <a:graphic>
          <a:graphicData uri="http://schemas.openxmlformats.org/drawingml/2006/table">
            <a:tbl>
              <a:tblPr/>
              <a:tblGrid>
                <a:gridCol w="928440"/>
                <a:gridCol w="885960"/>
                <a:gridCol w="893880"/>
                <a:gridCol w="984240"/>
                <a:gridCol w="1170000"/>
              </a:tblGrid>
              <a:tr h="51444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es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Kruskal-Wallis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Cuzick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rend test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nn-Whitney 0/1-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Mann-Whitney 3a/3b-3c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288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 IgA EL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953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7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 w="2880">
                      <a:solidFill>
                        <a:srgbClr val="000000"/>
                      </a:solidFill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 IgA BF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54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17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-GP 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88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11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tTG IgG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2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N/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336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nGliadin 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60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629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F-3x I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GAF-3x 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95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4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GP Scree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525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250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GP Ig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4342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087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228600"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DGP IgG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 w="2880">
                      <a:solidFill>
                        <a:srgbClr val="000000"/>
                      </a:solidFill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 w="2880">
                      <a:solidFill>
                        <a:srgbClr val="000000"/>
                      </a:solidFill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 </a:t>
                      </a: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&lt; 0.0001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32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7920" rIns="7920" tIns="79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fr-FR" sz="1200" spc="-1" strike="noStrike">
                          <a:solidFill>
                            <a:srgbClr val="000000"/>
                          </a:solidFill>
                          <a:latin typeface="Arial"/>
                        </a:rPr>
                        <a:t>0.0714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7920" marR="79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</a:tbl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37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1-11T18:14:12Z</dcterms:created>
  <dc:creator>LdC</dc:creator>
  <dc:description/>
  <dc:language>en-US</dc:language>
  <cp:lastModifiedBy>DE CHAISEMARTIN Luc</cp:lastModifiedBy>
  <cp:lastPrinted>2013-05-25T17:28:43Z</cp:lastPrinted>
  <dcterms:modified xsi:type="dcterms:W3CDTF">2015-05-18T11:08:54Z</dcterms:modified>
  <cp:revision>108</cp:revision>
  <dc:subject/>
  <dc:title>Présentation PowerPoint</dc:title>
</cp:coreProperties>
</file>